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howGuides="1">
      <p:cViewPr varScale="1">
        <p:scale>
          <a:sx n="79" d="100"/>
          <a:sy n="79" d="100"/>
        </p:scale>
        <p:origin x="82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A55EA-BA60-4765-AFDE-9E16FA3267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BAD4FD-E65E-4AE0-A47D-177A8BE869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3ECA1-4671-411D-BB38-B301E09EF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CD04A-AB6E-496E-A2BB-3AB6DF7DD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C3BCD-829E-4C90-B77A-961676675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095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CDC32-3BBB-488A-9C0E-8CE967CB4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E12241-D4B3-4817-96D5-C3E35F73CC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8210D-4104-4CB1-B562-06C06603D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055C3-E932-4115-85F0-5B2B424CD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75620A-0FD4-43CE-8C85-6DE943875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43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9B0556-B68F-4A8E-9BE6-662F6F2EF4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69016-DCDC-4217-87B7-AE206DF2C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1FB2A-D48B-4298-B584-B051C2B7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0866C-ED23-4EB7-88E5-A0BAB13A8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5A8F9-E7CC-4368-82DC-B636A31AF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561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7C162-E113-471C-95DB-137DE0B58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84F1B3-54E8-4A45-A9DC-AC62530B23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2FBCB7-5094-4ADE-BDD6-F97BDA803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B27FC4-8673-41E3-83AF-E0E5EECFD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67733-827C-4BA8-8C8B-23EBAC403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18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FE87F-3145-4D09-A4B9-743C47343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331719-9917-45BF-BCA8-499F47C7B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EA4D2-583F-4E11-8642-6A17F8DF2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EA9393-926B-44A8-90E8-457900644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F2CF8-6638-4BFA-9B42-AB43BF94C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938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4897C-02B0-4085-BBF7-BF56F1F02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B74D6-365F-4425-81A5-05F2DC686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EAD847-2330-4B34-BE1A-B147094CFC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6B54DC-E716-4AB4-B574-99C7AD359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48FA3E-F690-4496-ADED-0544667CB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D9A8A0-CB73-4F44-A5C0-A6A1D2144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608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6BE06-0E67-43DA-B7A0-A1DC19B0D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8F4AF0-C9CB-4D60-8BF9-4781211A50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F129C1-7FF7-47DB-8D7B-A48F6A5AF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01F605-9827-46A2-93B5-E5B4F33147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0EE2F9-6DE0-47BC-AC04-0990AD5AA8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8DB06E-726A-4F6D-9D45-1D2F4162C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B7BD35-5723-4AF2-BD4F-01A828508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76B483-E08B-48EC-A25C-EFDB8F3C6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087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7F61DC-5D53-4F55-B63C-2AC2F902F2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0AF1FC-34DC-43F8-A1B5-F2200E9FB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2B60EA-0C6E-4A4D-843E-6C342EE1B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74C134-3934-4DD5-9F71-026F757AF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345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4F817B-1CBD-4354-9E53-9CA27687A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682F95-4A1A-4586-A8F8-4EA396FE6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BE744A-03C6-43E8-B388-DD37A2C7E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226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DDE69-7D92-4188-A360-716A58392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9F4B3-5014-4C78-A419-C9E593F31C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67A462-1E9A-4CE1-BC8F-47C5599E47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BF2CA5-230D-4C02-8AF2-9ED39A49F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435F28-FEF1-4365-88C2-A222B903A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501F4F-3C2C-4910-A0D5-40E5C98C5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2493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FAA44-D729-4D07-9476-9F5C6B85D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19F375-2D5A-4B02-B0D5-41BD43DA2A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277E06-DC49-4ECE-827F-9229AA2AB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A09A1-19ED-4759-93C3-AD8EA6EC4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6900B1-7B06-4075-BB30-1C08A3784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023DE5-3BE7-4CEC-B1CB-E2AF8ED4A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8395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9DDC46-FF55-4E43-8ABE-2A0B8E52B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38AC6-75C5-499B-BC1F-9E080936D2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15D62-DDDB-43AA-98B2-0C566505FF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4B81EA-60F6-4064-9D7B-889D8CDCE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73613-6A02-40F1-AD4C-C5A3219829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1646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0B53D91-3B77-4AC6-80D9-91751AC27D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20" t="19402" b="8408"/>
          <a:stretch/>
        </p:blipFill>
        <p:spPr>
          <a:xfrm>
            <a:off x="655332" y="1885716"/>
            <a:ext cx="6724359" cy="310536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6DEDB3A-DB34-44F0-9D0B-493CCC84BD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376" t="15056" r="16528" b="5326"/>
          <a:stretch/>
        </p:blipFill>
        <p:spPr>
          <a:xfrm>
            <a:off x="6979500" y="151933"/>
            <a:ext cx="2964600" cy="17337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D032E1F-4D15-48AF-BCB3-E8453352227D}"/>
              </a:ext>
            </a:extLst>
          </p:cNvPr>
          <p:cNvSpPr txBox="1"/>
          <p:nvPr/>
        </p:nvSpPr>
        <p:spPr>
          <a:xfrm>
            <a:off x="7179045" y="2522595"/>
            <a:ext cx="15070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0 months</a:t>
            </a:r>
          </a:p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6 month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0FC55711-26C2-4C60-BFAF-0D3029FD1776}"/>
              </a:ext>
            </a:extLst>
          </p:cNvPr>
          <p:cNvSpPr>
            <a:spLocks noChangeAspect="1"/>
          </p:cNvSpPr>
          <p:nvPr/>
        </p:nvSpPr>
        <p:spPr>
          <a:xfrm>
            <a:off x="6992780" y="2878290"/>
            <a:ext cx="216000" cy="2160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8C2A8557-6B80-467E-AFFB-76E76783F7D7}"/>
              </a:ext>
            </a:extLst>
          </p:cNvPr>
          <p:cNvSpPr>
            <a:spLocks noChangeAspect="1"/>
          </p:cNvSpPr>
          <p:nvPr/>
        </p:nvSpPr>
        <p:spPr>
          <a:xfrm>
            <a:off x="6992780" y="2597302"/>
            <a:ext cx="216000" cy="216000"/>
          </a:xfrm>
          <a:prstGeom prst="ellipse">
            <a:avLst/>
          </a:prstGeom>
          <a:solidFill>
            <a:srgbClr val="00B050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2CF541-03FB-4496-B99D-C1AD0C8F59AD}"/>
              </a:ext>
            </a:extLst>
          </p:cNvPr>
          <p:cNvSpPr txBox="1"/>
          <p:nvPr/>
        </p:nvSpPr>
        <p:spPr>
          <a:xfrm>
            <a:off x="3181600" y="4991082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Sampl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392213-8C7F-41F0-AA31-35C08DD629D6}"/>
              </a:ext>
            </a:extLst>
          </p:cNvPr>
          <p:cNvSpPr txBox="1"/>
          <p:nvPr/>
        </p:nvSpPr>
        <p:spPr>
          <a:xfrm rot="16200000">
            <a:off x="-264068" y="3041561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t(1) (15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64D66D-4574-4065-90BA-2262635CB945}"/>
              </a:ext>
            </a:extLst>
          </p:cNvPr>
          <p:cNvSpPr txBox="1"/>
          <p:nvPr/>
        </p:nvSpPr>
        <p:spPr>
          <a:xfrm>
            <a:off x="2216463" y="5379464"/>
            <a:ext cx="3353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R</a:t>
            </a:r>
            <a:r>
              <a:rPr lang="en-GB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Y = 0.60	Q</a:t>
            </a:r>
            <a:r>
              <a:rPr lang="en-GB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Y = 0.34</a:t>
            </a:r>
            <a:endParaRPr lang="en-GB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367475-7F34-4024-88AE-A15D9F505C6E}"/>
              </a:ext>
            </a:extLst>
          </p:cNvPr>
          <p:cNvSpPr txBox="1"/>
          <p:nvPr/>
        </p:nvSpPr>
        <p:spPr>
          <a:xfrm>
            <a:off x="165100" y="6002402"/>
            <a:ext cx="109156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l </a:t>
            </a:r>
            <a:r>
              <a:rPr lang="en-GB" b="1"/>
              <a:t>Figure S2</a:t>
            </a:r>
            <a:r>
              <a:rPr lang="en-GB" b="1" dirty="0"/>
              <a:t>: </a:t>
            </a:r>
            <a:r>
              <a:rPr lang="en-GB" dirty="0"/>
              <a:t>OPLS-DA scores plot of the samples for timepoints 1 Vs 2. Variables are scaled to unit variance (CV-ANOVA p = 0.004). Inlet represents permutation testing (n = 99) for R</a:t>
            </a:r>
            <a:r>
              <a:rPr lang="en-GB" baseline="30000" dirty="0"/>
              <a:t>2</a:t>
            </a:r>
            <a:r>
              <a:rPr lang="en-GB" dirty="0"/>
              <a:t>Y (green) and Q</a:t>
            </a:r>
            <a:r>
              <a:rPr lang="en-GB" baseline="30000" dirty="0"/>
              <a:t>2</a:t>
            </a:r>
            <a:r>
              <a:rPr lang="en-GB" dirty="0"/>
              <a:t>Y (blue).</a:t>
            </a:r>
          </a:p>
        </p:txBody>
      </p:sp>
    </p:spTree>
    <p:extLst>
      <p:ext uri="{BB962C8B-B14F-4D97-AF65-F5344CB8AC3E}">
        <p14:creationId xmlns:p14="http://schemas.microsoft.com/office/powerpoint/2010/main" val="2223779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6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rkas, Panagiotis</dc:creator>
  <cp:lastModifiedBy>MDPI</cp:lastModifiedBy>
  <cp:revision>24</cp:revision>
  <dcterms:created xsi:type="dcterms:W3CDTF">2021-12-10T11:16:45Z</dcterms:created>
  <dcterms:modified xsi:type="dcterms:W3CDTF">2023-08-21T13:27:15Z</dcterms:modified>
</cp:coreProperties>
</file>